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  <p:sldId id="261" r:id="rId5"/>
    <p:sldId id="262" r:id="rId6"/>
    <p:sldId id="263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0" d="100"/>
          <a:sy n="60" d="100"/>
        </p:scale>
        <p:origin x="330" y="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FA434C-0DBC-4BA4-8A03-157C3E51C0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231E58-B52B-44B9-8A8F-E2D83EFC227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231E58-B52B-44B9-8A8F-E2D83EFC227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231E58-B52B-44B9-8A8F-E2D83EFC227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231E58-B52B-44B9-8A8F-E2D83EFC227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231E58-B52B-44B9-8A8F-E2D83EFC227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41BBF3-F344-458E-B3B9-F9DA27C980D3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54221-D182-4377-A610-10107AB1114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图片 3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81" y="400050"/>
            <a:ext cx="7572756" cy="605790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7937369" y="319511"/>
            <a:ext cx="4141847" cy="5693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 h and 36 h of </a:t>
            </a:r>
            <a:r>
              <a:rPr lang="el-GR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-6 is the results of 12 h.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: Mock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2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3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5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6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7-12 is the results of 36 h.</a:t>
            </a:r>
            <a:endParaRPr lang="en-US" altLang="zh-CN" sz="2400" b="1" i="0" dirty="0">
              <a:solidFill>
                <a:srgbClr val="101214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7: Mock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8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9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0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1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2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628645" y="3506910"/>
            <a:ext cx="2297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 2  3  4   5  6  7   8  9 </a:t>
            </a:r>
            <a:r>
              <a:rPr lang="en-US" altLang="zh-CN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11 12</a:t>
            </a:r>
            <a:endParaRPr lang="zh-CN" alt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936144" y="364831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936144" y="348962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936144" y="335922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936144" y="325710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828424" y="3164347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zh-CN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628645" y="3156127"/>
            <a:ext cx="2297424" cy="6277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401633" y="3829751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ne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 flipV="1">
            <a:off x="5721592" y="3735128"/>
            <a:ext cx="0" cy="18683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2936144" y="312456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 flipH="1">
            <a:off x="3206208" y="3771425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3206208" y="3605446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 flipH="1">
            <a:off x="3206208" y="3484468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H="1">
            <a:off x="3206208" y="3390214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H="1">
            <a:off x="3206208" y="3247675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>
            <a:off x="1935215" y="2745442"/>
            <a:ext cx="1693430" cy="11490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1879503" y="2739994"/>
            <a:ext cx="18490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 (</a:t>
            </a:r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Molecular weight</a:t>
            </a:r>
            <a:endParaRPr lang="en-US" altLang="zh-CN" sz="1200" b="0" i="0" dirty="0">
              <a:solidFill>
                <a:srgbClr val="FF0000"/>
              </a:solidFill>
              <a:effectLst/>
              <a:latin typeface="PingFang SC"/>
            </a:endParaRPr>
          </a:p>
          <a:p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 of protein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81" y="400050"/>
            <a:ext cx="7572756" cy="60579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364690" y="4298766"/>
            <a:ext cx="2464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  2  3   4   5  6  7   8  9  </a:t>
            </a:r>
            <a:r>
              <a:rPr lang="en-US" altLang="zh-CN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11  12</a:t>
            </a:r>
            <a:endParaRPr lang="zh-CN" alt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564469" y="3890214"/>
            <a:ext cx="1984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RSV  N-protein</a:t>
            </a:r>
            <a:r>
              <a:rPr lang="zh-CN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436487" y="3881993"/>
            <a:ext cx="2341109" cy="7384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137678" y="4621607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ne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 flipV="1">
            <a:off x="5457637" y="4526984"/>
            <a:ext cx="0" cy="18683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2747605" y="441189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747605" y="419664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747605" y="394470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 flipH="1">
            <a:off x="3017669" y="4535000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3017669" y="4312459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H="1">
            <a:off x="3017669" y="4067812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>
            <a:off x="1708968" y="3679385"/>
            <a:ext cx="1693430" cy="9787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685540" y="319511"/>
            <a:ext cx="4616439" cy="5693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 h and 36 h of PRRSV-N</a:t>
            </a:r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-6 is the results of 12 h.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: Mock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2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3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5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6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7-12 is the results of 36 h.</a:t>
            </a:r>
            <a:endParaRPr lang="en-US" altLang="zh-CN" sz="2400" b="1" i="0" dirty="0">
              <a:solidFill>
                <a:srgbClr val="101214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7: Mock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8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9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0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1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2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640403" y="3669678"/>
            <a:ext cx="18490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 (</a:t>
            </a:r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Molecular weight</a:t>
            </a:r>
            <a:endParaRPr lang="en-US" altLang="zh-CN" sz="1200" b="0" i="0" dirty="0">
              <a:solidFill>
                <a:srgbClr val="FF0000"/>
              </a:solidFill>
              <a:effectLst/>
              <a:latin typeface="PingFang SC"/>
            </a:endParaRPr>
          </a:p>
          <a:p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 of protein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81" y="400050"/>
            <a:ext cx="7572756" cy="60579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091317" y="3422067"/>
            <a:ext cx="23775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 2   3  4  5  6   7  8   9 </a:t>
            </a:r>
            <a:r>
              <a:rPr lang="en-US" altLang="zh-CN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 11 12</a:t>
            </a:r>
            <a:endParaRPr lang="zh-CN" alt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291096" y="3013515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zh-CN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091317" y="3005294"/>
            <a:ext cx="2297424" cy="7384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864305" y="3744908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ne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 flipV="1">
            <a:off x="5184264" y="3650285"/>
            <a:ext cx="0" cy="18683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2436524" y="361060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436524" y="345192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436524" y="332151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436524" y="321939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436524" y="308685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 flipH="1">
            <a:off x="2706588" y="3733717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2706588" y="3567738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 flipH="1">
            <a:off x="2706588" y="3446760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H="1">
            <a:off x="2706588" y="3352506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H="1">
            <a:off x="2706588" y="3209967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>
            <a:off x="1397887" y="2707734"/>
            <a:ext cx="1693430" cy="11490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937369" y="319511"/>
            <a:ext cx="4141847" cy="56938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h and 48 h of </a:t>
            </a:r>
            <a:r>
              <a:rPr lang="el-GR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-6 is the results of 24 h.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: Mock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2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3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5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6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7-12 is the results of 48 h.</a:t>
            </a:r>
            <a:endParaRPr lang="en-US" altLang="zh-CN" sz="2400" b="1" i="0" dirty="0">
              <a:solidFill>
                <a:srgbClr val="101214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7: Mock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8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9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0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1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2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339949" y="2694842"/>
            <a:ext cx="18490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 (</a:t>
            </a:r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Molecular weight</a:t>
            </a:r>
            <a:endParaRPr lang="en-US" altLang="zh-CN" sz="1200" b="0" i="0" dirty="0">
              <a:solidFill>
                <a:srgbClr val="FF0000"/>
              </a:solidFill>
              <a:effectLst/>
              <a:latin typeface="PingFang SC"/>
            </a:endParaRPr>
          </a:p>
          <a:p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 of protein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181" y="400050"/>
            <a:ext cx="7572756" cy="60579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3911448" y="3488057"/>
            <a:ext cx="2464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  2  3   4  5   6  7   8  9  </a:t>
            </a:r>
            <a:r>
              <a:rPr lang="en-US" altLang="zh-CN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11  12</a:t>
            </a:r>
            <a:endParaRPr lang="zh-CN" alt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111227" y="3079505"/>
            <a:ext cx="1984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RSV  N-protein</a:t>
            </a:r>
            <a:r>
              <a:rPr lang="zh-CN" alt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983245" y="3071284"/>
            <a:ext cx="2341109" cy="7384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684436" y="3810898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ne</a:t>
            </a:r>
            <a:endParaRPr lang="zh-CN" altLang="en-US" sz="16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 flipV="1">
            <a:off x="6004395" y="3716275"/>
            <a:ext cx="0" cy="18683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192483" y="2812997"/>
            <a:ext cx="18490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 (</a:t>
            </a:r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Molecular weight</a:t>
            </a:r>
            <a:endParaRPr lang="en-US" altLang="zh-CN" sz="1200" b="0" i="0" dirty="0">
              <a:solidFill>
                <a:srgbClr val="FF0000"/>
              </a:solidFill>
              <a:effectLst/>
              <a:latin typeface="PingFang SC"/>
            </a:endParaRPr>
          </a:p>
          <a:p>
            <a:r>
              <a:rPr lang="en-US" altLang="zh-CN" sz="1200" b="0" i="0" dirty="0">
                <a:solidFill>
                  <a:srgbClr val="FF0000"/>
                </a:solidFill>
                <a:effectLst/>
                <a:latin typeface="PingFang SC"/>
              </a:rPr>
              <a:t> of protein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zh-CN" sz="12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altLang="zh-CN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294363" y="360118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294363" y="338593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294363" y="313399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 flipH="1">
            <a:off x="3564427" y="3724291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3564427" y="3501750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 flipH="1">
            <a:off x="3564427" y="3257103"/>
            <a:ext cx="18049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>
            <a:off x="2244436" y="2803852"/>
            <a:ext cx="1704720" cy="104354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7685540" y="319511"/>
            <a:ext cx="4616439" cy="57554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 h and 48 h of PRRSV-N</a:t>
            </a:r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-6 is the results of 24 h.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: Mock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2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3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5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6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b="1" i="0" dirty="0">
                <a:solidFill>
                  <a:srgbClr val="10121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7-12 is the results of 48 h.</a:t>
            </a:r>
            <a:endParaRPr lang="en-US" altLang="zh-CN" sz="2400" b="1" i="0" dirty="0">
              <a:solidFill>
                <a:srgbClr val="101214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7: Mock</a:t>
            </a:r>
            <a:endParaRPr lang="en-US" altLang="zh-CN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8: Control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9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0: L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1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8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2: S-</a:t>
            </a:r>
            <a:r>
              <a:rPr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Rhe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/Ag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(16.0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en-US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9767b904-e3e6-47b4-b8f7-b11828568c11"/>
  <p:tag name="COMMONDATA" val="eyJoZGlkIjoiNThhMmZmZjJhMmU1YjhlNjAwZmFlOTMzYjhjZjczZDA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66</Words>
  <Application>WPS 演示</Application>
  <PresentationFormat>宽屏</PresentationFormat>
  <Paragraphs>140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5" baseType="lpstr">
      <vt:lpstr>Arial</vt:lpstr>
      <vt:lpstr>宋体</vt:lpstr>
      <vt:lpstr>Wingdings</vt:lpstr>
      <vt:lpstr>等线</vt:lpstr>
      <vt:lpstr>PingFang SC</vt:lpstr>
      <vt:lpstr>Segoe Print</vt:lpstr>
      <vt:lpstr>微软雅黑</vt:lpstr>
      <vt:lpstr>Arial Unicode MS</vt:lpstr>
      <vt:lpstr>等线 Light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彩凤 任</dc:creator>
  <cp:lastModifiedBy>努力奋斗</cp:lastModifiedBy>
  <cp:revision>38</cp:revision>
  <dcterms:created xsi:type="dcterms:W3CDTF">2023-08-30T04:07:00Z</dcterms:created>
  <dcterms:modified xsi:type="dcterms:W3CDTF">2023-09-07T00:11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DAB9C1AE264478C953EB54B336EAE48_13</vt:lpwstr>
  </property>
  <property fmtid="{D5CDD505-2E9C-101B-9397-08002B2CF9AE}" pid="3" name="KSOProductBuildVer">
    <vt:lpwstr>2052-11.1.0.14309</vt:lpwstr>
  </property>
</Properties>
</file>